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1B63057-9A38-45D0-AB1B-8C7E62497727}" v="21" dt="2024-10-18T06:55:25.84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1632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chel Carling" userId="ff23d13f-8e86-47dc-a8d0-4f3d9c02838f" providerId="ADAL" clId="{81B63057-9A38-45D0-AB1B-8C7E62497727}"/>
    <pc:docChg chg="undo custSel addSld modSld">
      <pc:chgData name="Rachel Carling" userId="ff23d13f-8e86-47dc-a8d0-4f3d9c02838f" providerId="ADAL" clId="{81B63057-9A38-45D0-AB1B-8C7E62497727}" dt="2024-10-18T06:55:57.231" v="356" actId="6549"/>
      <pc:docMkLst>
        <pc:docMk/>
      </pc:docMkLst>
      <pc:sldChg chg="addSp modSp mod">
        <pc:chgData name="Rachel Carling" userId="ff23d13f-8e86-47dc-a8d0-4f3d9c02838f" providerId="ADAL" clId="{81B63057-9A38-45D0-AB1B-8C7E62497727}" dt="2024-10-18T06:50:59.011" v="324" actId="20577"/>
        <pc:sldMkLst>
          <pc:docMk/>
          <pc:sldMk cId="84989951" sldId="256"/>
        </pc:sldMkLst>
        <pc:spChg chg="mod">
          <ac:chgData name="Rachel Carling" userId="ff23d13f-8e86-47dc-a8d0-4f3d9c02838f" providerId="ADAL" clId="{81B63057-9A38-45D0-AB1B-8C7E62497727}" dt="2024-10-18T06:39:36.630" v="38" actId="1076"/>
          <ac:spMkLst>
            <pc:docMk/>
            <pc:sldMk cId="84989951" sldId="256"/>
            <ac:spMk id="7" creationId="{DA07C605-7DBB-B105-A8F5-43C547341899}"/>
          </ac:spMkLst>
        </pc:spChg>
        <pc:spChg chg="mod">
          <ac:chgData name="Rachel Carling" userId="ff23d13f-8e86-47dc-a8d0-4f3d9c02838f" providerId="ADAL" clId="{81B63057-9A38-45D0-AB1B-8C7E62497727}" dt="2024-10-18T06:39:28.773" v="37" actId="1076"/>
          <ac:spMkLst>
            <pc:docMk/>
            <pc:sldMk cId="84989951" sldId="256"/>
            <ac:spMk id="8" creationId="{79E57B23-8AF6-7CF1-F522-B108979D5EF0}"/>
          </ac:spMkLst>
        </pc:spChg>
        <pc:spChg chg="add mod">
          <ac:chgData name="Rachel Carling" userId="ff23d13f-8e86-47dc-a8d0-4f3d9c02838f" providerId="ADAL" clId="{81B63057-9A38-45D0-AB1B-8C7E62497727}" dt="2024-10-18T06:50:59.011" v="324" actId="20577"/>
          <ac:spMkLst>
            <pc:docMk/>
            <pc:sldMk cId="84989951" sldId="256"/>
            <ac:spMk id="10" creationId="{6CD7D934-72A6-2607-3739-C17E86A45114}"/>
          </ac:spMkLst>
        </pc:spChg>
        <pc:picChg chg="mod">
          <ac:chgData name="Rachel Carling" userId="ff23d13f-8e86-47dc-a8d0-4f3d9c02838f" providerId="ADAL" clId="{81B63057-9A38-45D0-AB1B-8C7E62497727}" dt="2024-10-18T06:38:20.373" v="34" actId="1076"/>
          <ac:picMkLst>
            <pc:docMk/>
            <pc:sldMk cId="84989951" sldId="256"/>
            <ac:picMk id="4" creationId="{FD554162-421B-8B90-4217-D84DAAA44841}"/>
          </ac:picMkLst>
        </pc:picChg>
        <pc:picChg chg="mod">
          <ac:chgData name="Rachel Carling" userId="ff23d13f-8e86-47dc-a8d0-4f3d9c02838f" providerId="ADAL" clId="{81B63057-9A38-45D0-AB1B-8C7E62497727}" dt="2024-10-18T06:42:14.180" v="52" actId="1076"/>
          <ac:picMkLst>
            <pc:docMk/>
            <pc:sldMk cId="84989951" sldId="256"/>
            <ac:picMk id="5" creationId="{D19864FE-C421-1016-6A8A-11A8C0593FFB}"/>
          </ac:picMkLst>
        </pc:picChg>
        <pc:picChg chg="mod">
          <ac:chgData name="Rachel Carling" userId="ff23d13f-8e86-47dc-a8d0-4f3d9c02838f" providerId="ADAL" clId="{81B63057-9A38-45D0-AB1B-8C7E62497727}" dt="2024-10-18T06:39:19.045" v="36" actId="1076"/>
          <ac:picMkLst>
            <pc:docMk/>
            <pc:sldMk cId="84989951" sldId="256"/>
            <ac:picMk id="6" creationId="{00F42BBE-BCEE-C0CD-EFB4-0EDD57E8584F}"/>
          </ac:picMkLst>
        </pc:picChg>
      </pc:sldChg>
      <pc:sldChg chg="addSp delSp modSp add mod">
        <pc:chgData name="Rachel Carling" userId="ff23d13f-8e86-47dc-a8d0-4f3d9c02838f" providerId="ADAL" clId="{81B63057-9A38-45D0-AB1B-8C7E62497727}" dt="2024-10-18T06:55:53.713" v="354" actId="20577"/>
        <pc:sldMkLst>
          <pc:docMk/>
          <pc:sldMk cId="4101640942" sldId="257"/>
        </pc:sldMkLst>
        <pc:spChg chg="add mod">
          <ac:chgData name="Rachel Carling" userId="ff23d13f-8e86-47dc-a8d0-4f3d9c02838f" providerId="ADAL" clId="{81B63057-9A38-45D0-AB1B-8C7E62497727}" dt="2024-10-18T06:40:06.247" v="39"/>
          <ac:spMkLst>
            <pc:docMk/>
            <pc:sldMk cId="4101640942" sldId="257"/>
            <ac:spMk id="14" creationId="{9E95EF93-39A5-5B32-1C05-BE0E5817F9FE}"/>
          </ac:spMkLst>
        </pc:spChg>
        <pc:spChg chg="add mod">
          <ac:chgData name="Rachel Carling" userId="ff23d13f-8e86-47dc-a8d0-4f3d9c02838f" providerId="ADAL" clId="{81B63057-9A38-45D0-AB1B-8C7E62497727}" dt="2024-10-18T06:40:06.247" v="39"/>
          <ac:spMkLst>
            <pc:docMk/>
            <pc:sldMk cId="4101640942" sldId="257"/>
            <ac:spMk id="15" creationId="{3713C78B-C8D4-E02F-7863-B5951221637A}"/>
          </ac:spMkLst>
        </pc:spChg>
        <pc:spChg chg="add mod">
          <ac:chgData name="Rachel Carling" userId="ff23d13f-8e86-47dc-a8d0-4f3d9c02838f" providerId="ADAL" clId="{81B63057-9A38-45D0-AB1B-8C7E62497727}" dt="2024-10-18T06:40:06.247" v="39"/>
          <ac:spMkLst>
            <pc:docMk/>
            <pc:sldMk cId="4101640942" sldId="257"/>
            <ac:spMk id="16" creationId="{99421E8E-0D53-24E9-3B4C-C10DAB4AEF07}"/>
          </ac:spMkLst>
        </pc:spChg>
        <pc:spChg chg="add mod">
          <ac:chgData name="Rachel Carling" userId="ff23d13f-8e86-47dc-a8d0-4f3d9c02838f" providerId="ADAL" clId="{81B63057-9A38-45D0-AB1B-8C7E62497727}" dt="2024-10-18T06:55:53.713" v="354" actId="20577"/>
          <ac:spMkLst>
            <pc:docMk/>
            <pc:sldMk cId="4101640942" sldId="257"/>
            <ac:spMk id="17" creationId="{9B264947-C41E-91CB-3014-D05B7CEA7226}"/>
          </ac:spMkLst>
        </pc:spChg>
        <pc:picChg chg="add del mod">
          <ac:chgData name="Rachel Carling" userId="ff23d13f-8e86-47dc-a8d0-4f3d9c02838f" providerId="ADAL" clId="{81B63057-9A38-45D0-AB1B-8C7E62497727}" dt="2024-10-18T06:36:07.810" v="20" actId="478"/>
          <ac:picMkLst>
            <pc:docMk/>
            <pc:sldMk cId="4101640942" sldId="257"/>
            <ac:picMk id="2" creationId="{D054A068-562D-559C-CEC1-4AB9983905AC}"/>
          </ac:picMkLst>
        </pc:picChg>
        <pc:picChg chg="add del mod">
          <ac:chgData name="Rachel Carling" userId="ff23d13f-8e86-47dc-a8d0-4f3d9c02838f" providerId="ADAL" clId="{81B63057-9A38-45D0-AB1B-8C7E62497727}" dt="2024-10-18T06:36:11.790" v="22" actId="478"/>
          <ac:picMkLst>
            <pc:docMk/>
            <pc:sldMk cId="4101640942" sldId="257"/>
            <ac:picMk id="3" creationId="{1500C124-8F10-8651-DB1A-CBCF49DF46D5}"/>
          </ac:picMkLst>
        </pc:picChg>
        <pc:picChg chg="del">
          <ac:chgData name="Rachel Carling" userId="ff23d13f-8e86-47dc-a8d0-4f3d9c02838f" providerId="ADAL" clId="{81B63057-9A38-45D0-AB1B-8C7E62497727}" dt="2024-10-18T06:31:04.124" v="5" actId="478"/>
          <ac:picMkLst>
            <pc:docMk/>
            <pc:sldMk cId="4101640942" sldId="257"/>
            <ac:picMk id="4" creationId="{FD554162-421B-8B90-4217-D84DAAA44841}"/>
          </ac:picMkLst>
        </pc:picChg>
        <pc:picChg chg="del">
          <ac:chgData name="Rachel Carling" userId="ff23d13f-8e86-47dc-a8d0-4f3d9c02838f" providerId="ADAL" clId="{81B63057-9A38-45D0-AB1B-8C7E62497727}" dt="2024-10-18T06:31:05.608" v="7" actId="478"/>
          <ac:picMkLst>
            <pc:docMk/>
            <pc:sldMk cId="4101640942" sldId="257"/>
            <ac:picMk id="5" creationId="{D19864FE-C421-1016-6A8A-11A8C0593FFB}"/>
          </ac:picMkLst>
        </pc:picChg>
        <pc:picChg chg="del">
          <ac:chgData name="Rachel Carling" userId="ff23d13f-8e86-47dc-a8d0-4f3d9c02838f" providerId="ADAL" clId="{81B63057-9A38-45D0-AB1B-8C7E62497727}" dt="2024-10-18T06:31:04.827" v="6" actId="478"/>
          <ac:picMkLst>
            <pc:docMk/>
            <pc:sldMk cId="4101640942" sldId="257"/>
            <ac:picMk id="6" creationId="{00F42BBE-BCEE-C0CD-EFB4-0EDD57E8584F}"/>
          </ac:picMkLst>
        </pc:picChg>
        <pc:picChg chg="add del mod">
          <ac:chgData name="Rachel Carling" userId="ff23d13f-8e86-47dc-a8d0-4f3d9c02838f" providerId="ADAL" clId="{81B63057-9A38-45D0-AB1B-8C7E62497727}" dt="2024-10-18T06:36:01.701" v="18" actId="478"/>
          <ac:picMkLst>
            <pc:docMk/>
            <pc:sldMk cId="4101640942" sldId="257"/>
            <ac:picMk id="10" creationId="{299B7C1D-82CF-BB03-1D90-F86A892271A2}"/>
          </ac:picMkLst>
        </pc:picChg>
        <pc:picChg chg="add mod">
          <ac:chgData name="Rachel Carling" userId="ff23d13f-8e86-47dc-a8d0-4f3d9c02838f" providerId="ADAL" clId="{81B63057-9A38-45D0-AB1B-8C7E62497727}" dt="2024-10-18T06:37:02.022" v="31" actId="1076"/>
          <ac:picMkLst>
            <pc:docMk/>
            <pc:sldMk cId="4101640942" sldId="257"/>
            <ac:picMk id="11" creationId="{C4F5E024-55FA-EEEA-F099-7E3EF571D1AD}"/>
          </ac:picMkLst>
        </pc:picChg>
        <pc:picChg chg="add mod">
          <ac:chgData name="Rachel Carling" userId="ff23d13f-8e86-47dc-a8d0-4f3d9c02838f" providerId="ADAL" clId="{81B63057-9A38-45D0-AB1B-8C7E62497727}" dt="2024-10-18T06:37:39.549" v="33" actId="1076"/>
          <ac:picMkLst>
            <pc:docMk/>
            <pc:sldMk cId="4101640942" sldId="257"/>
            <ac:picMk id="12" creationId="{A6BC2246-3364-19F6-E2C3-8020AE38ED92}"/>
          </ac:picMkLst>
        </pc:picChg>
        <pc:picChg chg="add mod">
          <ac:chgData name="Rachel Carling" userId="ff23d13f-8e86-47dc-a8d0-4f3d9c02838f" providerId="ADAL" clId="{81B63057-9A38-45D0-AB1B-8C7E62497727}" dt="2024-10-18T06:37:02.022" v="31" actId="1076"/>
          <ac:picMkLst>
            <pc:docMk/>
            <pc:sldMk cId="4101640942" sldId="257"/>
            <ac:picMk id="13" creationId="{13508058-D432-5CD3-CF75-81DAF7051EAE}"/>
          </ac:picMkLst>
        </pc:picChg>
      </pc:sldChg>
      <pc:sldChg chg="addSp delSp modSp add mod">
        <pc:chgData name="Rachel Carling" userId="ff23d13f-8e86-47dc-a8d0-4f3d9c02838f" providerId="ADAL" clId="{81B63057-9A38-45D0-AB1B-8C7E62497727}" dt="2024-10-18T06:55:57.231" v="356" actId="6549"/>
        <pc:sldMkLst>
          <pc:docMk/>
          <pc:sldMk cId="785456373" sldId="258"/>
        </pc:sldMkLst>
        <pc:spChg chg="add mod">
          <ac:chgData name="Rachel Carling" userId="ff23d13f-8e86-47dc-a8d0-4f3d9c02838f" providerId="ADAL" clId="{81B63057-9A38-45D0-AB1B-8C7E62497727}" dt="2024-10-18T06:42:49.989" v="55"/>
          <ac:spMkLst>
            <pc:docMk/>
            <pc:sldMk cId="785456373" sldId="258"/>
            <ac:spMk id="11" creationId="{4457D69F-A29F-BAE0-E6C4-A92C7D5F8CBA}"/>
          </ac:spMkLst>
        </pc:spChg>
        <pc:spChg chg="add mod">
          <ac:chgData name="Rachel Carling" userId="ff23d13f-8e86-47dc-a8d0-4f3d9c02838f" providerId="ADAL" clId="{81B63057-9A38-45D0-AB1B-8C7E62497727}" dt="2024-10-18T06:55:25.845" v="352" actId="164"/>
          <ac:spMkLst>
            <pc:docMk/>
            <pc:sldMk cId="785456373" sldId="258"/>
            <ac:spMk id="12" creationId="{47314C23-DE2E-EAEE-C40C-A8CF8A6C60B2}"/>
          </ac:spMkLst>
        </pc:spChg>
        <pc:spChg chg="add mod">
          <ac:chgData name="Rachel Carling" userId="ff23d13f-8e86-47dc-a8d0-4f3d9c02838f" providerId="ADAL" clId="{81B63057-9A38-45D0-AB1B-8C7E62497727}" dt="2024-10-18T06:42:49.989" v="55"/>
          <ac:spMkLst>
            <pc:docMk/>
            <pc:sldMk cId="785456373" sldId="258"/>
            <ac:spMk id="13" creationId="{D9D6C027-0090-0E20-8A55-ABC5B322FC28}"/>
          </ac:spMkLst>
        </pc:spChg>
        <pc:spChg chg="add mod">
          <ac:chgData name="Rachel Carling" userId="ff23d13f-8e86-47dc-a8d0-4f3d9c02838f" providerId="ADAL" clId="{81B63057-9A38-45D0-AB1B-8C7E62497727}" dt="2024-10-18T06:55:57.231" v="356" actId="6549"/>
          <ac:spMkLst>
            <pc:docMk/>
            <pc:sldMk cId="785456373" sldId="258"/>
            <ac:spMk id="14" creationId="{E0382145-F146-62FA-D25C-FD4760AED634}"/>
          </ac:spMkLst>
        </pc:spChg>
        <pc:spChg chg="add mod">
          <ac:chgData name="Rachel Carling" userId="ff23d13f-8e86-47dc-a8d0-4f3d9c02838f" providerId="ADAL" clId="{81B63057-9A38-45D0-AB1B-8C7E62497727}" dt="2024-10-18T06:55:25.845" v="352" actId="164"/>
          <ac:spMkLst>
            <pc:docMk/>
            <pc:sldMk cId="785456373" sldId="258"/>
            <ac:spMk id="23" creationId="{59AEB0A6-9D18-042C-0271-2000A409F910}"/>
          </ac:spMkLst>
        </pc:spChg>
        <pc:grpChg chg="add mod">
          <ac:chgData name="Rachel Carling" userId="ff23d13f-8e86-47dc-a8d0-4f3d9c02838f" providerId="ADAL" clId="{81B63057-9A38-45D0-AB1B-8C7E62497727}" dt="2024-10-18T06:55:25.845" v="352" actId="164"/>
          <ac:grpSpMkLst>
            <pc:docMk/>
            <pc:sldMk cId="785456373" sldId="258"/>
            <ac:grpSpMk id="24" creationId="{51314DA2-898D-803F-94B9-76EBC0DE7A82}"/>
          </ac:grpSpMkLst>
        </pc:grpChg>
        <pc:picChg chg="add mod">
          <ac:chgData name="Rachel Carling" userId="ff23d13f-8e86-47dc-a8d0-4f3d9c02838f" providerId="ADAL" clId="{81B63057-9A38-45D0-AB1B-8C7E62497727}" dt="2024-10-18T06:41:44.576" v="50" actId="1076"/>
          <ac:picMkLst>
            <pc:docMk/>
            <pc:sldMk cId="785456373" sldId="258"/>
            <ac:picMk id="2" creationId="{9AAF5B27-2B8F-6F25-7883-2964705A3EC0}"/>
          </ac:picMkLst>
        </pc:picChg>
        <pc:picChg chg="add mod">
          <ac:chgData name="Rachel Carling" userId="ff23d13f-8e86-47dc-a8d0-4f3d9c02838f" providerId="ADAL" clId="{81B63057-9A38-45D0-AB1B-8C7E62497727}" dt="2024-10-18T06:42:28.181" v="54" actId="1076"/>
          <ac:picMkLst>
            <pc:docMk/>
            <pc:sldMk cId="785456373" sldId="258"/>
            <ac:picMk id="3" creationId="{8FBF9314-61E8-FA67-A8B6-FF45282A6125}"/>
          </ac:picMkLst>
        </pc:picChg>
        <pc:picChg chg="del">
          <ac:chgData name="Rachel Carling" userId="ff23d13f-8e86-47dc-a8d0-4f3d9c02838f" providerId="ADAL" clId="{81B63057-9A38-45D0-AB1B-8C7E62497727}" dt="2024-10-18T06:31:01.589" v="3" actId="478"/>
          <ac:picMkLst>
            <pc:docMk/>
            <pc:sldMk cId="785456373" sldId="258"/>
            <ac:picMk id="4" creationId="{FD554162-421B-8B90-4217-D84DAAA44841}"/>
          </ac:picMkLst>
        </pc:picChg>
        <pc:picChg chg="del">
          <ac:chgData name="Rachel Carling" userId="ff23d13f-8e86-47dc-a8d0-4f3d9c02838f" providerId="ADAL" clId="{81B63057-9A38-45D0-AB1B-8C7E62497727}" dt="2024-10-18T06:31:02.421" v="4" actId="478"/>
          <ac:picMkLst>
            <pc:docMk/>
            <pc:sldMk cId="785456373" sldId="258"/>
            <ac:picMk id="5" creationId="{D19864FE-C421-1016-6A8A-11A8C0593FFB}"/>
          </ac:picMkLst>
        </pc:picChg>
        <pc:picChg chg="del">
          <ac:chgData name="Rachel Carling" userId="ff23d13f-8e86-47dc-a8d0-4f3d9c02838f" providerId="ADAL" clId="{81B63057-9A38-45D0-AB1B-8C7E62497727}" dt="2024-10-18T06:31:00.821" v="2" actId="478"/>
          <ac:picMkLst>
            <pc:docMk/>
            <pc:sldMk cId="785456373" sldId="258"/>
            <ac:picMk id="6" creationId="{00F42BBE-BCEE-C0CD-EFB4-0EDD57E8584F}"/>
          </ac:picMkLst>
        </pc:picChg>
        <pc:picChg chg="add mod">
          <ac:chgData name="Rachel Carling" userId="ff23d13f-8e86-47dc-a8d0-4f3d9c02838f" providerId="ADAL" clId="{81B63057-9A38-45D0-AB1B-8C7E62497727}" dt="2024-10-18T06:55:25.845" v="352" actId="164"/>
          <ac:picMkLst>
            <pc:docMk/>
            <pc:sldMk cId="785456373" sldId="258"/>
            <ac:picMk id="10" creationId="{E7237D1A-06BF-97F1-7345-B197D4349063}"/>
          </ac:picMkLst>
        </pc:picChg>
        <pc:picChg chg="add del mod">
          <ac:chgData name="Rachel Carling" userId="ff23d13f-8e86-47dc-a8d0-4f3d9c02838f" providerId="ADAL" clId="{81B63057-9A38-45D0-AB1B-8C7E62497727}" dt="2024-10-18T06:55:03.610" v="348" actId="478"/>
          <ac:picMkLst>
            <pc:docMk/>
            <pc:sldMk cId="785456373" sldId="258"/>
            <ac:picMk id="16" creationId="{5C3BDE94-84FB-6E83-FCD6-63247257E3F5}"/>
          </ac:picMkLst>
        </pc:picChg>
        <pc:picChg chg="add del">
          <ac:chgData name="Rachel Carling" userId="ff23d13f-8e86-47dc-a8d0-4f3d9c02838f" providerId="ADAL" clId="{81B63057-9A38-45D0-AB1B-8C7E62497727}" dt="2024-10-18T06:54:06.799" v="338" actId="22"/>
          <ac:picMkLst>
            <pc:docMk/>
            <pc:sldMk cId="785456373" sldId="258"/>
            <ac:picMk id="18" creationId="{C40B1A51-5EE9-9D2D-647D-F5420863159F}"/>
          </ac:picMkLst>
        </pc:picChg>
        <pc:picChg chg="add del">
          <ac:chgData name="Rachel Carling" userId="ff23d13f-8e86-47dc-a8d0-4f3d9c02838f" providerId="ADAL" clId="{81B63057-9A38-45D0-AB1B-8C7E62497727}" dt="2024-10-18T06:54:21.213" v="340" actId="22"/>
          <ac:picMkLst>
            <pc:docMk/>
            <pc:sldMk cId="785456373" sldId="258"/>
            <ac:picMk id="20" creationId="{8D900B88-6753-ADFC-5D07-A5B2D5CEFB1F}"/>
          </ac:picMkLst>
        </pc:picChg>
        <pc:picChg chg="add del mod">
          <ac:chgData name="Rachel Carling" userId="ff23d13f-8e86-47dc-a8d0-4f3d9c02838f" providerId="ADAL" clId="{81B63057-9A38-45D0-AB1B-8C7E62497727}" dt="2024-10-18T06:54:47.887" v="346" actId="22"/>
          <ac:picMkLst>
            <pc:docMk/>
            <pc:sldMk cId="785456373" sldId="258"/>
            <ac:picMk id="22" creationId="{ACB7DEE1-2787-5CE3-76FF-A6A68F160B3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4959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40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0415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0965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3394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5962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6005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2177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0013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7436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6029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8F243F-7BEC-4E03-90E7-5DCFDC3ADEDB}" type="datetimeFigureOut">
              <a:rPr lang="en-GB" smtClean="0"/>
              <a:t>18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0FB820-A02A-4B6D-9BA0-7BBC77C411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9771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D554162-421B-8B90-4217-D84DAAA448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3000" y="677041"/>
            <a:ext cx="6480000" cy="200623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19864FE-C421-1016-6A8A-11A8C0593F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3000" y="4593665"/>
            <a:ext cx="6480000" cy="200623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F42BBE-BCEE-C0CD-EFB4-0EDD57E8584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13000" y="2587427"/>
            <a:ext cx="6480000" cy="200623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A07C605-7DBB-B105-A8F5-43C547341899}"/>
              </a:ext>
            </a:extLst>
          </p:cNvPr>
          <p:cNvSpPr txBox="1"/>
          <p:nvPr/>
        </p:nvSpPr>
        <p:spPr>
          <a:xfrm>
            <a:off x="7229475" y="830669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9E57B23-8AF6-7CF1-F522-B108979D5EF0}"/>
              </a:ext>
            </a:extLst>
          </p:cNvPr>
          <p:cNvSpPr txBox="1"/>
          <p:nvPr/>
        </p:nvSpPr>
        <p:spPr>
          <a:xfrm>
            <a:off x="7215850" y="4678271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57743D9-6C31-B775-FD1F-FF3377454ED2}"/>
              </a:ext>
            </a:extLst>
          </p:cNvPr>
          <p:cNvSpPr txBox="1"/>
          <p:nvPr/>
        </p:nvSpPr>
        <p:spPr>
          <a:xfrm>
            <a:off x="7226269" y="276788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CD7D934-72A6-2607-3739-C17E86A45114}"/>
              </a:ext>
            </a:extLst>
          </p:cNvPr>
          <p:cNvSpPr txBox="1"/>
          <p:nvPr/>
        </p:nvSpPr>
        <p:spPr>
          <a:xfrm>
            <a:off x="304800" y="116235"/>
            <a:ext cx="84010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Total ion current chromatograms from an individual with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tinidas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ficiency when the solvent extract was evaporated at A) ambient temperature, B) </a:t>
            </a:r>
            <a:r>
              <a:rPr lang="en-GB" sz="1200" kern="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40˚C plus 15 mins and  C) 60˚C plus 15 mins. 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9899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DA07C605-7DBB-B105-A8F5-43C547341899}"/>
              </a:ext>
            </a:extLst>
          </p:cNvPr>
          <p:cNvSpPr txBox="1"/>
          <p:nvPr/>
        </p:nvSpPr>
        <p:spPr>
          <a:xfrm>
            <a:off x="7229475" y="876300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9E57B23-8AF6-7CF1-F522-B108979D5EF0}"/>
              </a:ext>
            </a:extLst>
          </p:cNvPr>
          <p:cNvSpPr txBox="1"/>
          <p:nvPr/>
        </p:nvSpPr>
        <p:spPr>
          <a:xfrm>
            <a:off x="7223202" y="4831449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57743D9-6C31-B775-FD1F-FF3377454ED2}"/>
              </a:ext>
            </a:extLst>
          </p:cNvPr>
          <p:cNvSpPr txBox="1"/>
          <p:nvPr/>
        </p:nvSpPr>
        <p:spPr>
          <a:xfrm>
            <a:off x="7226269" y="276788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4F5E024-55FA-EEEA-F099-7E3EF571D1A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713000" y="4609248"/>
            <a:ext cx="6480000" cy="2006237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6BC2246-3364-19F6-E2C3-8020AE38ED9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713000" y="2603011"/>
            <a:ext cx="6480000" cy="2006237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3508058-D432-5CD3-CF75-81DAF7051EA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713000" y="654100"/>
            <a:ext cx="6480000" cy="2006237"/>
          </a:xfrm>
          <a:prstGeom prst="rect">
            <a:avLst/>
          </a:prstGeom>
          <a:noFill/>
          <a:ln>
            <a:noFill/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E95EF93-39A5-5B32-1C05-BE0E5817F9FE}"/>
              </a:ext>
            </a:extLst>
          </p:cNvPr>
          <p:cNvSpPr txBox="1"/>
          <p:nvPr/>
        </p:nvSpPr>
        <p:spPr>
          <a:xfrm>
            <a:off x="7381875" y="983069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713C78B-C8D4-E02F-7863-B5951221637A}"/>
              </a:ext>
            </a:extLst>
          </p:cNvPr>
          <p:cNvSpPr txBox="1"/>
          <p:nvPr/>
        </p:nvSpPr>
        <p:spPr>
          <a:xfrm>
            <a:off x="7368250" y="4830671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9421E8E-0D53-24E9-3B4C-C10DAB4AEF07}"/>
              </a:ext>
            </a:extLst>
          </p:cNvPr>
          <p:cNvSpPr txBox="1"/>
          <p:nvPr/>
        </p:nvSpPr>
        <p:spPr>
          <a:xfrm>
            <a:off x="7378669" y="292028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B264947-C41E-91CB-3014-D05B7CEA7226}"/>
              </a:ext>
            </a:extLst>
          </p:cNvPr>
          <p:cNvSpPr txBox="1"/>
          <p:nvPr/>
        </p:nvSpPr>
        <p:spPr>
          <a:xfrm>
            <a:off x="304800" y="116235"/>
            <a:ext cx="84010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Total ion current chromatograms from an individual with MSUD when the solvent extract was evaporated at A) ambient temperature, B) </a:t>
            </a:r>
            <a:r>
              <a:rPr lang="en-GB" sz="1200" kern="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40˚C plus 15 mins and  C) 60˚C plus 15 mins. 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16409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DA07C605-7DBB-B105-A8F5-43C547341899}"/>
              </a:ext>
            </a:extLst>
          </p:cNvPr>
          <p:cNvSpPr txBox="1"/>
          <p:nvPr/>
        </p:nvSpPr>
        <p:spPr>
          <a:xfrm>
            <a:off x="7229475" y="876300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9E57B23-8AF6-7CF1-F522-B108979D5EF0}"/>
              </a:ext>
            </a:extLst>
          </p:cNvPr>
          <p:cNvSpPr txBox="1"/>
          <p:nvPr/>
        </p:nvSpPr>
        <p:spPr>
          <a:xfrm>
            <a:off x="7223202" y="4831449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57743D9-6C31-B775-FD1F-FF3377454ED2}"/>
              </a:ext>
            </a:extLst>
          </p:cNvPr>
          <p:cNvSpPr txBox="1"/>
          <p:nvPr/>
        </p:nvSpPr>
        <p:spPr>
          <a:xfrm>
            <a:off x="7226269" y="276788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AAF5B27-2B8F-6F25-7883-2964705A3EC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713000" y="654100"/>
            <a:ext cx="6480000" cy="2006237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FBF9314-61E8-FA67-A8B6-FF45282A612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713000" y="2603187"/>
            <a:ext cx="6480000" cy="2006237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457D69F-A29F-BAE0-E6C4-A92C7D5F8CBA}"/>
              </a:ext>
            </a:extLst>
          </p:cNvPr>
          <p:cNvSpPr txBox="1"/>
          <p:nvPr/>
        </p:nvSpPr>
        <p:spPr>
          <a:xfrm>
            <a:off x="7381875" y="983069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9D6C027-0090-0E20-8A55-ABC5B322FC28}"/>
              </a:ext>
            </a:extLst>
          </p:cNvPr>
          <p:cNvSpPr txBox="1"/>
          <p:nvPr/>
        </p:nvSpPr>
        <p:spPr>
          <a:xfrm>
            <a:off x="7378669" y="292028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0382145-F146-62FA-D25C-FD4760AED634}"/>
              </a:ext>
            </a:extLst>
          </p:cNvPr>
          <p:cNvSpPr txBox="1"/>
          <p:nvPr/>
        </p:nvSpPr>
        <p:spPr>
          <a:xfrm>
            <a:off x="304800" y="116235"/>
            <a:ext cx="84010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ion current chromatograms from an individual with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etoti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oglycemi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en the solvent extract was evaporated at A) ambient temperature, B) </a:t>
            </a:r>
            <a:r>
              <a:rPr lang="en-GB" sz="1200" kern="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40˚C plus 15 mins and  C) 60˚C plus 15 mins. 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51314DA2-898D-803F-94B9-76EBC0DE7A82}"/>
              </a:ext>
            </a:extLst>
          </p:cNvPr>
          <p:cNvGrpSpPr/>
          <p:nvPr/>
        </p:nvGrpSpPr>
        <p:grpSpPr>
          <a:xfrm>
            <a:off x="1713000" y="4582897"/>
            <a:ext cx="6480000" cy="2006237"/>
            <a:chOff x="1713000" y="4582897"/>
            <a:chExt cx="6480000" cy="2006237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7237D1A-06BF-97F1-7345-B197D434906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1713000" y="4582897"/>
              <a:ext cx="6480000" cy="200623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7314C23-DE2E-EAEE-C40C-A8CF8A6C60B2}"/>
                </a:ext>
              </a:extLst>
            </p:cNvPr>
            <p:cNvSpPr txBox="1"/>
            <p:nvPr/>
          </p:nvSpPr>
          <p:spPr>
            <a:xfrm>
              <a:off x="7368250" y="4830671"/>
              <a:ext cx="3449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C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59AEB0A6-9D18-042C-0271-2000A409F910}"/>
                </a:ext>
              </a:extLst>
            </p:cNvPr>
            <p:cNvSpPr/>
            <p:nvPr/>
          </p:nvSpPr>
          <p:spPr>
            <a:xfrm>
              <a:off x="7777163" y="5653088"/>
              <a:ext cx="109537" cy="4810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7854563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143</Words>
  <Application>Microsoft Office PowerPoint</Application>
  <PresentationFormat>A4 Paper (210x297 mm)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chel Carling</dc:creator>
  <cp:lastModifiedBy>Rachel Carling</cp:lastModifiedBy>
  <cp:revision>1</cp:revision>
  <dcterms:created xsi:type="dcterms:W3CDTF">2024-10-18T06:25:27Z</dcterms:created>
  <dcterms:modified xsi:type="dcterms:W3CDTF">2024-10-18T06:55:58Z</dcterms:modified>
</cp:coreProperties>
</file>